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091" y="263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1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25413" y="62616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15794" y="40168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769843" y="7769996"/>
            <a:ext cx="52130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a </a:t>
            </a:r>
            <a:r>
              <a:rPr lang="en-US" altLang="ja-JP" sz="1200" dirty="0"/>
              <a:t>Association of FABP7, UCP1, and hypoxia </a:t>
            </a:r>
            <a:r>
              <a:rPr lang="en-US" altLang="ja-JP" sz="1200" dirty="0" err="1"/>
              <a:t>ssGSEA</a:t>
            </a:r>
            <a:r>
              <a:rPr lang="en-US" altLang="ja-JP" sz="1200" dirty="0"/>
              <a:t> quartile in the </a:t>
            </a:r>
            <a:r>
              <a:rPr lang="en-US" altLang="ja-JP" sz="1200" dirty="0" err="1"/>
              <a:t>Metabric</a:t>
            </a:r>
            <a:r>
              <a:rPr lang="en-US" altLang="ja-JP" sz="1200" dirty="0"/>
              <a:t> (n = 1904, upper panels) and TCGA (n = 960, lower panels) breast cancer cohorts. The scatter plots of all samples (left), ER+ tumors (middle) and ER negative tumors (right) are shown. X and y axes show UCP1 and FABP7 mRNA expression, respectively. Hypoxia </a:t>
            </a:r>
            <a:r>
              <a:rPr lang="en-US" altLang="ja-JP" sz="1200" dirty="0" err="1"/>
              <a:t>ssGSEA</a:t>
            </a:r>
            <a:r>
              <a:rPr lang="en-US" altLang="ja-JP" sz="1200" dirty="0"/>
              <a:t> quartiles were indicated using different colors (orange, green, blue and purple). </a:t>
            </a:r>
            <a:r>
              <a:rPr lang="en-US" altLang="ja-JP" sz="1200" b="1" dirty="0"/>
              <a:t>b</a:t>
            </a:r>
            <a:r>
              <a:rPr lang="en-US" altLang="ja-JP" sz="1200" dirty="0"/>
              <a:t> Correlation analyses of hypoxia </a:t>
            </a:r>
            <a:r>
              <a:rPr lang="en-US" altLang="ja-JP" sz="1200" dirty="0" err="1"/>
              <a:t>ssGSEA</a:t>
            </a:r>
            <a:r>
              <a:rPr lang="en-US" altLang="ja-JP" sz="1200" dirty="0"/>
              <a:t> with FABP7 (upper panels) and UCP1 expression (lower panels).  </a:t>
            </a:r>
            <a:endParaRPr lang="ja-JP" altLang="en-US" sz="1200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BE1848E9-9AF8-4715-A233-9FE572366F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2502" y="4031210"/>
            <a:ext cx="3839589" cy="3602764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DB5D4D2-5B3B-4A1E-A7E7-A60061AA30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2502" y="667029"/>
            <a:ext cx="4906989" cy="1683020"/>
          </a:xfrm>
          <a:prstGeom prst="rect">
            <a:avLst/>
          </a:prstGeom>
        </p:spPr>
      </p:pic>
      <p:pic>
        <p:nvPicPr>
          <p:cNvPr id="76" name="図 75">
            <a:extLst>
              <a:ext uri="{FF2B5EF4-FFF2-40B4-BE49-F238E27FC236}">
                <a16:creationId xmlns:a16="http://schemas.microsoft.com/office/drawing/2014/main" id="{1A11BFE0-8A50-4F5B-8CCE-01387330ED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0706" y="2315710"/>
            <a:ext cx="4930579" cy="1662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26</TotalTime>
  <Words>121</Words>
  <Application>Microsoft Office PowerPoint</Application>
  <PresentationFormat>A4 210 x 297 mm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29</cp:revision>
  <dcterms:created xsi:type="dcterms:W3CDTF">2017-03-29T14:34:10Z</dcterms:created>
  <dcterms:modified xsi:type="dcterms:W3CDTF">2020-01-11T16:39:10Z</dcterms:modified>
</cp:coreProperties>
</file>